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EEC379B-BEEA-0440-ACD1-C0C270B237F7}" v="4" dt="2024-11-08T16:35:38.10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28"/>
    <p:restoredTop sz="96115"/>
  </p:normalViewPr>
  <p:slideViewPr>
    <p:cSldViewPr snapToGrid="0">
      <p:cViewPr varScale="1">
        <p:scale>
          <a:sx n="121" d="100"/>
          <a:sy n="121" d="100"/>
        </p:scale>
        <p:origin x="45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ce Côté" userId="491ff76e-7bd0-4aca-bb65-325f4c6ba843" providerId="ADAL" clId="{8EEC379B-BEEA-0440-ACD1-C0C270B237F7}"/>
    <pc:docChg chg="undo custSel delSld modSld">
      <pc:chgData name="France Côté" userId="491ff76e-7bd0-4aca-bb65-325f4c6ba843" providerId="ADAL" clId="{8EEC379B-BEEA-0440-ACD1-C0C270B237F7}" dt="2024-11-08T16:38:19.778" v="95" actId="20577"/>
      <pc:docMkLst>
        <pc:docMk/>
      </pc:docMkLst>
      <pc:sldChg chg="addSp delSp modSp mod">
        <pc:chgData name="France Côté" userId="491ff76e-7bd0-4aca-bb65-325f4c6ba843" providerId="ADAL" clId="{8EEC379B-BEEA-0440-ACD1-C0C270B237F7}" dt="2024-11-08T16:38:19.778" v="95" actId="20577"/>
        <pc:sldMkLst>
          <pc:docMk/>
          <pc:sldMk cId="2923443352" sldId="256"/>
        </pc:sldMkLst>
        <pc:spChg chg="mod">
          <ac:chgData name="France Côté" userId="491ff76e-7bd0-4aca-bb65-325f4c6ba843" providerId="ADAL" clId="{8EEC379B-BEEA-0440-ACD1-C0C270B237F7}" dt="2024-11-08T16:38:19.778" v="95" actId="20577"/>
          <ac:spMkLst>
            <pc:docMk/>
            <pc:sldMk cId="2923443352" sldId="256"/>
            <ac:spMk id="4" creationId="{F37FF7CD-EF12-A386-6705-C5F93994D4A5}"/>
          </ac:spMkLst>
        </pc:spChg>
        <pc:spChg chg="add mod">
          <ac:chgData name="France Côté" userId="491ff76e-7bd0-4aca-bb65-325f4c6ba843" providerId="ADAL" clId="{8EEC379B-BEEA-0440-ACD1-C0C270B237F7}" dt="2024-11-08T16:33:51.494" v="80" actId="20577"/>
          <ac:spMkLst>
            <pc:docMk/>
            <pc:sldMk cId="2923443352" sldId="256"/>
            <ac:spMk id="11" creationId="{E420821A-49FE-CA24-A22D-587CAF7AC522}"/>
          </ac:spMkLst>
        </pc:spChg>
        <pc:spChg chg="add del mod">
          <ac:chgData name="France Côté" userId="491ff76e-7bd0-4aca-bb65-325f4c6ba843" providerId="ADAL" clId="{8EEC379B-BEEA-0440-ACD1-C0C270B237F7}" dt="2024-11-08T16:34:02.398" v="83" actId="14100"/>
          <ac:spMkLst>
            <pc:docMk/>
            <pc:sldMk cId="2923443352" sldId="256"/>
            <ac:spMk id="19" creationId="{492D3260-293B-EFA1-9996-3B54389C504A}"/>
          </ac:spMkLst>
        </pc:spChg>
        <pc:spChg chg="mod">
          <ac:chgData name="France Côté" userId="491ff76e-7bd0-4aca-bb65-325f4c6ba843" providerId="ADAL" clId="{8EEC379B-BEEA-0440-ACD1-C0C270B237F7}" dt="2024-11-08T16:35:38.105" v="88"/>
          <ac:spMkLst>
            <pc:docMk/>
            <pc:sldMk cId="2923443352" sldId="256"/>
            <ac:spMk id="70" creationId="{6E30674E-AFB8-C0D9-BACA-01D185BF69B3}"/>
          </ac:spMkLst>
        </pc:spChg>
        <pc:spChg chg="mod">
          <ac:chgData name="France Côté" userId="491ff76e-7bd0-4aca-bb65-325f4c6ba843" providerId="ADAL" clId="{8EEC379B-BEEA-0440-ACD1-C0C270B237F7}" dt="2024-11-08T16:35:38.105" v="88"/>
          <ac:spMkLst>
            <pc:docMk/>
            <pc:sldMk cId="2923443352" sldId="256"/>
            <ac:spMk id="76" creationId="{FAC5DF01-AFB0-F9C0-3122-E196C6700BC6}"/>
          </ac:spMkLst>
        </pc:spChg>
        <pc:spChg chg="mod">
          <ac:chgData name="France Côté" userId="491ff76e-7bd0-4aca-bb65-325f4c6ba843" providerId="ADAL" clId="{8EEC379B-BEEA-0440-ACD1-C0C270B237F7}" dt="2024-11-08T16:35:38.105" v="88"/>
          <ac:spMkLst>
            <pc:docMk/>
            <pc:sldMk cId="2923443352" sldId="256"/>
            <ac:spMk id="77" creationId="{0F2A1285-C6F4-8D1B-4E3D-A0B10E97E397}"/>
          </ac:spMkLst>
        </pc:spChg>
        <pc:spChg chg="mod">
          <ac:chgData name="France Côté" userId="491ff76e-7bd0-4aca-bb65-325f4c6ba843" providerId="ADAL" clId="{8EEC379B-BEEA-0440-ACD1-C0C270B237F7}" dt="2024-11-08T16:35:38.105" v="88"/>
          <ac:spMkLst>
            <pc:docMk/>
            <pc:sldMk cId="2923443352" sldId="256"/>
            <ac:spMk id="78" creationId="{A2F44EF2-7349-58AC-2DF7-8D6D79C1D3EF}"/>
          </ac:spMkLst>
        </pc:spChg>
        <pc:spChg chg="mod">
          <ac:chgData name="France Côté" userId="491ff76e-7bd0-4aca-bb65-325f4c6ba843" providerId="ADAL" clId="{8EEC379B-BEEA-0440-ACD1-C0C270B237F7}" dt="2024-11-08T16:35:38.105" v="88"/>
          <ac:spMkLst>
            <pc:docMk/>
            <pc:sldMk cId="2923443352" sldId="256"/>
            <ac:spMk id="79" creationId="{90A147F9-CE8F-7ABC-38B0-5A5661CAD88C}"/>
          </ac:spMkLst>
        </pc:spChg>
        <pc:spChg chg="mod">
          <ac:chgData name="France Côté" userId="491ff76e-7bd0-4aca-bb65-325f4c6ba843" providerId="ADAL" clId="{8EEC379B-BEEA-0440-ACD1-C0C270B237F7}" dt="2024-11-08T16:35:38.105" v="88"/>
          <ac:spMkLst>
            <pc:docMk/>
            <pc:sldMk cId="2923443352" sldId="256"/>
            <ac:spMk id="80" creationId="{C28F7B6B-0C99-7EC9-20F9-FAD03B293D41}"/>
          </ac:spMkLst>
        </pc:spChg>
        <pc:spChg chg="mod">
          <ac:chgData name="France Côté" userId="491ff76e-7bd0-4aca-bb65-325f4c6ba843" providerId="ADAL" clId="{8EEC379B-BEEA-0440-ACD1-C0C270B237F7}" dt="2024-11-08T16:35:38.105" v="88"/>
          <ac:spMkLst>
            <pc:docMk/>
            <pc:sldMk cId="2923443352" sldId="256"/>
            <ac:spMk id="82" creationId="{4E819CA9-C92B-EC44-24F6-CBDF34BF3A1B}"/>
          </ac:spMkLst>
        </pc:spChg>
        <pc:spChg chg="mod">
          <ac:chgData name="France Côté" userId="491ff76e-7bd0-4aca-bb65-325f4c6ba843" providerId="ADAL" clId="{8EEC379B-BEEA-0440-ACD1-C0C270B237F7}" dt="2024-11-08T16:35:38.105" v="88"/>
          <ac:spMkLst>
            <pc:docMk/>
            <pc:sldMk cId="2923443352" sldId="256"/>
            <ac:spMk id="83" creationId="{23CA76EF-DA4A-9A2D-CC65-BF3AF923F3EE}"/>
          </ac:spMkLst>
        </pc:spChg>
        <pc:grpChg chg="add mod">
          <ac:chgData name="France Côté" userId="491ff76e-7bd0-4aca-bb65-325f4c6ba843" providerId="ADAL" clId="{8EEC379B-BEEA-0440-ACD1-C0C270B237F7}" dt="2024-11-08T16:35:57.348" v="91" actId="1076"/>
          <ac:grpSpMkLst>
            <pc:docMk/>
            <pc:sldMk cId="2923443352" sldId="256"/>
            <ac:grpSpMk id="20" creationId="{85703773-D8FD-1D6E-BF92-9736952178F3}"/>
          </ac:grpSpMkLst>
        </pc:grpChg>
        <pc:grpChg chg="mod">
          <ac:chgData name="France Côté" userId="491ff76e-7bd0-4aca-bb65-325f4c6ba843" providerId="ADAL" clId="{8EEC379B-BEEA-0440-ACD1-C0C270B237F7}" dt="2024-11-08T16:35:38.105" v="88"/>
          <ac:grpSpMkLst>
            <pc:docMk/>
            <pc:sldMk cId="2923443352" sldId="256"/>
            <ac:grpSpMk id="53" creationId="{9E0BD384-3351-7217-28DA-3E55F5B58304}"/>
          </ac:grpSpMkLst>
        </pc:grpChg>
        <pc:grpChg chg="mod">
          <ac:chgData name="France Côté" userId="491ff76e-7bd0-4aca-bb65-325f4c6ba843" providerId="ADAL" clId="{8EEC379B-BEEA-0440-ACD1-C0C270B237F7}" dt="2024-11-08T16:35:38.105" v="88"/>
          <ac:grpSpMkLst>
            <pc:docMk/>
            <pc:sldMk cId="2923443352" sldId="256"/>
            <ac:grpSpMk id="72" creationId="{6EE0C509-386E-2A43-9FE2-596BAA7EC7E7}"/>
          </ac:grpSpMkLst>
        </pc:grpChg>
        <pc:grpChg chg="mod">
          <ac:chgData name="France Côté" userId="491ff76e-7bd0-4aca-bb65-325f4c6ba843" providerId="ADAL" clId="{8EEC379B-BEEA-0440-ACD1-C0C270B237F7}" dt="2024-11-08T16:35:38.105" v="88"/>
          <ac:grpSpMkLst>
            <pc:docMk/>
            <pc:sldMk cId="2923443352" sldId="256"/>
            <ac:grpSpMk id="74" creationId="{4A1073A5-9145-172A-D524-DE635112C5ED}"/>
          </ac:grpSpMkLst>
        </pc:grpChg>
        <pc:grpChg chg="mod">
          <ac:chgData name="France Côté" userId="491ff76e-7bd0-4aca-bb65-325f4c6ba843" providerId="ADAL" clId="{8EEC379B-BEEA-0440-ACD1-C0C270B237F7}" dt="2024-11-08T16:35:38.105" v="88"/>
          <ac:grpSpMkLst>
            <pc:docMk/>
            <pc:sldMk cId="2923443352" sldId="256"/>
            <ac:grpSpMk id="75" creationId="{C3FD7ADE-1E01-8C6B-32B1-93E1E0D9279C}"/>
          </ac:grpSpMkLst>
        </pc:grpChg>
        <pc:grpChg chg="mod">
          <ac:chgData name="France Côté" userId="491ff76e-7bd0-4aca-bb65-325f4c6ba843" providerId="ADAL" clId="{8EEC379B-BEEA-0440-ACD1-C0C270B237F7}" dt="2024-11-08T16:35:38.105" v="88"/>
          <ac:grpSpMkLst>
            <pc:docMk/>
            <pc:sldMk cId="2923443352" sldId="256"/>
            <ac:grpSpMk id="81" creationId="{91A1B5C5-EF59-EC4E-8732-9BFF082555C8}"/>
          </ac:grpSpMkLst>
        </pc:grpChg>
        <pc:picChg chg="mod">
          <ac:chgData name="France Côté" userId="491ff76e-7bd0-4aca-bb65-325f4c6ba843" providerId="ADAL" clId="{8EEC379B-BEEA-0440-ACD1-C0C270B237F7}" dt="2024-11-08T16:35:38.105" v="88"/>
          <ac:picMkLst>
            <pc:docMk/>
            <pc:sldMk cId="2923443352" sldId="256"/>
            <ac:picMk id="71" creationId="{0CAC32F0-11A7-B185-30EA-D7304E1F70C4}"/>
          </ac:picMkLst>
        </pc:picChg>
        <pc:picChg chg="mod">
          <ac:chgData name="France Côté" userId="491ff76e-7bd0-4aca-bb65-325f4c6ba843" providerId="ADAL" clId="{8EEC379B-BEEA-0440-ACD1-C0C270B237F7}" dt="2024-11-08T16:35:38.105" v="88"/>
          <ac:picMkLst>
            <pc:docMk/>
            <pc:sldMk cId="2923443352" sldId="256"/>
            <ac:picMk id="73" creationId="{A19391BD-9A49-4FB9-D2E9-020CFC660494}"/>
          </ac:picMkLst>
        </pc:picChg>
        <pc:cxnChg chg="mod">
          <ac:chgData name="France Côté" userId="491ff76e-7bd0-4aca-bb65-325f4c6ba843" providerId="ADAL" clId="{8EEC379B-BEEA-0440-ACD1-C0C270B237F7}" dt="2024-11-08T16:35:38.105" v="88"/>
          <ac:cxnSpMkLst>
            <pc:docMk/>
            <pc:sldMk cId="2923443352" sldId="256"/>
            <ac:cxnSpMk id="68" creationId="{50B1FDA4-9FDA-EF47-4D91-413A895AC305}"/>
          </ac:cxnSpMkLst>
        </pc:cxnChg>
      </pc:sldChg>
      <pc:sldChg chg="modSp del mod">
        <pc:chgData name="France Côté" userId="491ff76e-7bd0-4aca-bb65-325f4c6ba843" providerId="ADAL" clId="{8EEC379B-BEEA-0440-ACD1-C0C270B237F7}" dt="2024-11-08T16:35:47.377" v="90" actId="2696"/>
        <pc:sldMkLst>
          <pc:docMk/>
          <pc:sldMk cId="2326856200" sldId="257"/>
        </pc:sldMkLst>
        <pc:spChg chg="mod">
          <ac:chgData name="France Côté" userId="491ff76e-7bd0-4aca-bb65-325f4c6ba843" providerId="ADAL" clId="{8EEC379B-BEEA-0440-ACD1-C0C270B237F7}" dt="2024-11-08T16:31:23.309" v="15" actId="20577"/>
          <ac:spMkLst>
            <pc:docMk/>
            <pc:sldMk cId="2326856200" sldId="257"/>
            <ac:spMk id="4" creationId="{F37FF7CD-EF12-A386-6705-C5F93994D4A5}"/>
          </ac:spMkLst>
        </pc:spChg>
        <pc:spChg chg="mod">
          <ac:chgData name="France Côté" userId="491ff76e-7bd0-4aca-bb65-325f4c6ba843" providerId="ADAL" clId="{8EEC379B-BEEA-0440-ACD1-C0C270B237F7}" dt="2024-11-08T16:34:26.814" v="85" actId="14100"/>
          <ac:spMkLst>
            <pc:docMk/>
            <pc:sldMk cId="2326856200" sldId="257"/>
            <ac:spMk id="19" creationId="{EA86B7DE-E926-46BD-A797-EB54060D544A}"/>
          </ac:spMkLst>
        </pc:spChg>
        <pc:spChg chg="mod">
          <ac:chgData name="France Côté" userId="491ff76e-7bd0-4aca-bb65-325f4c6ba843" providerId="ADAL" clId="{8EEC379B-BEEA-0440-ACD1-C0C270B237F7}" dt="2024-11-08T16:34:31.148" v="87" actId="14100"/>
          <ac:spMkLst>
            <pc:docMk/>
            <pc:sldMk cId="2326856200" sldId="257"/>
            <ac:spMk id="20" creationId="{45D0073A-83FC-BC9A-6BA0-794A5381F05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3D1971-90C5-DC59-EC8D-3B270BDE5C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5E9F8C5-EC5F-0942-3396-32A029659B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CA"/>
              <a:t>Modifier le style des sous-titres du masque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B42F567-8DC2-8ACC-88AB-4F5F1B10B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8F6BF2B-C166-F293-F571-DBBEE6F44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5C4FCFC-747C-EDF5-48B2-4B542E8E8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83982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01BE97-07A1-D3C0-9A15-5EE1ED8038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8548F1F-8A95-BB65-F297-69794D3763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E94183B-C4CB-61A4-9B50-A7225172D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936197D-81B8-749A-BE8F-518BAC148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301ED0-CA7B-12C7-C105-2B1A8E82C4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4530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D53C8648-5F0F-01B3-4AAB-5835EF5196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E12FFE9-C97C-01E1-98BF-D9F9CC88C4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B7E31BA-C897-A7DD-12A6-EFE6DF3A1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224B93E-B0AB-2308-C15F-E0C40119EB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5D71F63-DE86-5223-C616-1A94E2DF7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7044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D22773A-ABA0-C5BC-21E0-BCE0CEB1A8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72F8432-5ADC-D284-9833-366BED9D17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B6767A8-9849-7B86-14EB-695CEE80B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E8712D2-34E0-F07D-2843-DB52045E6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1C4E005-8FFC-FCFD-6485-9FDF85FFE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4869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181E274-448F-6847-3AB0-7074805B67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B647490-DA4B-78C1-6E8A-134020BE20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CC9B433-0A76-27EE-0016-65A09DFE3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4D8346E-6790-2EAB-614E-F01CD7F7D1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0E03DB2-9C54-1226-A9DC-359749808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5481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8D0C741-AC08-84A5-36E8-E5E720D060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AC0BA8D-F382-4277-3F42-7F1CE02961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F354B6F-2CB9-B1AB-9202-315A4FCAF0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4C02E6-198E-A6C7-30F2-0D23482DD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44EADA5-82E0-0965-F785-306809CA3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26CA751-FD2C-FFCB-07F9-F4E2F317C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4688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201AD8-7568-0431-5AE7-AAA92D76E0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BB80455-3EBB-C923-3962-A6DEC92534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DA80A3A-19B6-D822-25E9-49D9879AB3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0D2AFCE-C82C-162B-568D-3188037D75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0405DA0-9213-C516-C8A1-919A8DFC27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9CCDAE8-ADF0-62A7-4236-4BEF865A5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5CCFF64-4E88-C785-FD17-6B4E7FC4F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8EE53AC-8A5B-3989-E95C-C8C66121C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4407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8C59865-65C7-69E4-B32B-B1B9214C9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41F57EA-6E90-A900-744C-7F2AF8166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65E66E8-63B8-BEF1-79EC-F0B162B47E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373FBD7-F5F7-F9CF-1932-870006ED4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00353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2C40F11-0B09-310F-798F-E3EED1A2B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F4763D27-8D2B-FF92-A12B-61C358D7C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37DCBE0-CF1D-B391-BE45-08792AAE2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0605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340B7EC-A244-B2C9-4A59-28B748A1C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0107B74-F502-6041-A44E-D76C5F2BED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14EF28B-43C7-283E-608E-2EF59644CC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862BC79-54A1-DB80-1591-6DBE9AAAF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D61D378-2286-93A5-D8B1-AF02D1C97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1656BAA-F1BF-FD34-9DD0-FD449545A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78422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26DED37-5D8F-3CA4-62DB-3EF4B7BF10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6CB50FA1-6292-DCA8-6AFD-E0580CD0FE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BE3473A-2ECE-C7C1-57C0-E0B251B08F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047EF7F-2B3C-8327-2263-C4BD8125C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D8F8007-911D-D6BC-42B7-9614C92E9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F8762E7-E498-D84B-18F1-CC7A1A27F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3532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58D829A-A652-E6E3-B912-DF2793CDC6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5FCF211-6984-D69A-95CD-9558E5CA1B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5DEE906-3323-8415-27D9-057801A47A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33BEE-8A8B-8F4B-AF24-2CD4129BCC3B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287ED53-0766-04F0-803A-F928EA0D01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F787691-5934-B6CC-0B31-FC15B750DE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797901-D3FB-2D49-A673-E620FCBA49DB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6427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F37FF7CD-EF12-A386-6705-C5F93994D4A5}"/>
              </a:ext>
            </a:extLst>
          </p:cNvPr>
          <p:cNvSpPr txBox="1"/>
          <p:nvPr/>
        </p:nvSpPr>
        <p:spPr>
          <a:xfrm>
            <a:off x="315311" y="294289"/>
            <a:ext cx="4351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STAT3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B41D4B6E-DED0-7394-F534-2AB314A9EF0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186" t="47054" r="45225" b="29524"/>
          <a:stretch/>
        </p:blipFill>
        <p:spPr>
          <a:xfrm>
            <a:off x="1815548" y="1881808"/>
            <a:ext cx="2610678" cy="1272209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48886457-5C6B-C37B-24BF-0AE582FA775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6224" t="11467" r="18882" b="65667"/>
          <a:stretch/>
        </p:blipFill>
        <p:spPr>
          <a:xfrm>
            <a:off x="5711687" y="1994451"/>
            <a:ext cx="1934817" cy="1242032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56D76FBC-E4F8-A97A-C77F-A1AAD261424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803" t="12687" r="32608" b="63891"/>
          <a:stretch/>
        </p:blipFill>
        <p:spPr>
          <a:xfrm>
            <a:off x="1815548" y="3691757"/>
            <a:ext cx="2610678" cy="127221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55E529E6-3EC0-08CA-AA02-983B227C28C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1944" t="44937" r="33163" b="31641"/>
          <a:stretch/>
        </p:blipFill>
        <p:spPr>
          <a:xfrm>
            <a:off x="5711687" y="3775839"/>
            <a:ext cx="1934817" cy="1272210"/>
          </a:xfrm>
          <a:prstGeom prst="rect">
            <a:avLst/>
          </a:prstGeom>
        </p:spPr>
      </p:pic>
      <p:grpSp>
        <p:nvGrpSpPr>
          <p:cNvPr id="12" name="Groupe 11">
            <a:extLst>
              <a:ext uri="{FF2B5EF4-FFF2-40B4-BE49-F238E27FC236}">
                <a16:creationId xmlns:a16="http://schemas.microsoft.com/office/drawing/2014/main" id="{CD6FF962-CA03-E619-7B91-0D007F39CEEE}"/>
              </a:ext>
            </a:extLst>
          </p:cNvPr>
          <p:cNvGrpSpPr/>
          <p:nvPr/>
        </p:nvGrpSpPr>
        <p:grpSpPr>
          <a:xfrm>
            <a:off x="1986973" y="949025"/>
            <a:ext cx="2429748" cy="947854"/>
            <a:chOff x="1104861" y="1005302"/>
            <a:chExt cx="2429748" cy="947854"/>
          </a:xfrm>
        </p:grpSpPr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262AA97E-C327-A070-55B6-724BE14EEB94}"/>
                </a:ext>
              </a:extLst>
            </p:cNvPr>
            <p:cNvSpPr txBox="1"/>
            <p:nvPr/>
          </p:nvSpPr>
          <p:spPr>
            <a:xfrm rot="16200000">
              <a:off x="1174593" y="1340729"/>
              <a:ext cx="9478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LPS 1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877D076A-030A-9D72-C048-66B52B0D1FF2}"/>
                </a:ext>
              </a:extLst>
            </p:cNvPr>
            <p:cNvSpPr txBox="1"/>
            <p:nvPr/>
          </p:nvSpPr>
          <p:spPr>
            <a:xfrm rot="16200000">
              <a:off x="2747481" y="1340729"/>
              <a:ext cx="9478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HSJ633 3 </a:t>
              </a:r>
            </a:p>
          </p:txBody>
        </p:sp>
        <p:grpSp>
          <p:nvGrpSpPr>
            <p:cNvPr id="15" name="Groupe 14">
              <a:extLst>
                <a:ext uri="{FF2B5EF4-FFF2-40B4-BE49-F238E27FC236}">
                  <a16:creationId xmlns:a16="http://schemas.microsoft.com/office/drawing/2014/main" id="{01433D3F-F5C6-D2BA-0FFA-520E8ED149D0}"/>
                </a:ext>
              </a:extLst>
            </p:cNvPr>
            <p:cNvGrpSpPr/>
            <p:nvPr/>
          </p:nvGrpSpPr>
          <p:grpSpPr>
            <a:xfrm>
              <a:off x="1104861" y="1005302"/>
              <a:ext cx="2429748" cy="947854"/>
              <a:chOff x="1104861" y="1005302"/>
              <a:chExt cx="2429748" cy="947854"/>
            </a:xfrm>
          </p:grpSpPr>
          <p:sp>
            <p:nvSpPr>
              <p:cNvPr id="16" name="ZoneTexte 15">
                <a:extLst>
                  <a:ext uri="{FF2B5EF4-FFF2-40B4-BE49-F238E27FC236}">
                    <a16:creationId xmlns:a16="http://schemas.microsoft.com/office/drawing/2014/main" id="{DA776CF8-EBCB-1B2F-A40A-DDA7CF1B1234}"/>
                  </a:ext>
                </a:extLst>
              </p:cNvPr>
              <p:cNvSpPr txBox="1"/>
              <p:nvPr/>
            </p:nvSpPr>
            <p:spPr>
              <a:xfrm rot="16200000">
                <a:off x="769434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SHAM 1 </a:t>
                </a:r>
              </a:p>
            </p:txBody>
          </p:sp>
          <p:sp>
            <p:nvSpPr>
              <p:cNvPr id="17" name="ZoneTexte 16">
                <a:extLst>
                  <a:ext uri="{FF2B5EF4-FFF2-40B4-BE49-F238E27FC236}">
                    <a16:creationId xmlns:a16="http://schemas.microsoft.com/office/drawing/2014/main" id="{344E3DF8-C5E0-1CB4-3E2B-EB3F330EA6E8}"/>
                  </a:ext>
                </a:extLst>
              </p:cNvPr>
              <p:cNvSpPr txBox="1"/>
              <p:nvPr/>
            </p:nvSpPr>
            <p:spPr>
              <a:xfrm rot="16200000">
                <a:off x="966438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SHAM 2 </a:t>
                </a:r>
              </a:p>
            </p:txBody>
          </p:sp>
          <p:sp>
            <p:nvSpPr>
              <p:cNvPr id="18" name="ZoneTexte 17">
                <a:extLst>
                  <a:ext uri="{FF2B5EF4-FFF2-40B4-BE49-F238E27FC236}">
                    <a16:creationId xmlns:a16="http://schemas.microsoft.com/office/drawing/2014/main" id="{D39B640D-7883-233F-A95E-D3D468AFD43A}"/>
                  </a:ext>
                </a:extLst>
              </p:cNvPr>
              <p:cNvSpPr txBox="1"/>
              <p:nvPr/>
            </p:nvSpPr>
            <p:spPr>
              <a:xfrm rot="16200000">
                <a:off x="1387354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LPS 2</a:t>
                </a:r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009DF989-4400-DE79-88C7-616F904242B6}"/>
                  </a:ext>
                </a:extLst>
              </p:cNvPr>
              <p:cNvSpPr txBox="1"/>
              <p:nvPr/>
            </p:nvSpPr>
            <p:spPr>
              <a:xfrm rot="16200000">
                <a:off x="1953241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Sham 3 </a:t>
                </a:r>
              </a:p>
            </p:txBody>
          </p: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4332071D-50FD-F329-7C70-A977ED98371C}"/>
                  </a:ext>
                </a:extLst>
              </p:cNvPr>
              <p:cNvSpPr txBox="1"/>
              <p:nvPr/>
            </p:nvSpPr>
            <p:spPr>
              <a:xfrm rot="16200000">
                <a:off x="2134167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Sham 4</a:t>
                </a:r>
              </a:p>
            </p:txBody>
          </p:sp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id="{6822567A-3AEE-4D81-2436-85F2CB34A14C}"/>
                  </a:ext>
                </a:extLst>
              </p:cNvPr>
              <p:cNvSpPr txBox="1"/>
              <p:nvPr/>
            </p:nvSpPr>
            <p:spPr>
              <a:xfrm rot="16200000">
                <a:off x="2331171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LPS 3</a:t>
                </a:r>
              </a:p>
            </p:txBody>
          </p:sp>
          <p:sp>
            <p:nvSpPr>
              <p:cNvPr id="24" name="ZoneTexte 23">
                <a:extLst>
                  <a:ext uri="{FF2B5EF4-FFF2-40B4-BE49-F238E27FC236}">
                    <a16:creationId xmlns:a16="http://schemas.microsoft.com/office/drawing/2014/main" id="{D86C9E57-FD4D-6D39-1527-ADDAF34815B1}"/>
                  </a:ext>
                </a:extLst>
              </p:cNvPr>
              <p:cNvSpPr txBox="1"/>
              <p:nvPr/>
            </p:nvSpPr>
            <p:spPr>
              <a:xfrm rot="16200000">
                <a:off x="2550477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LPS 4 </a:t>
                </a:r>
              </a:p>
            </p:txBody>
          </p:sp>
          <p:sp>
            <p:nvSpPr>
              <p:cNvPr id="25" name="ZoneTexte 24">
                <a:extLst>
                  <a:ext uri="{FF2B5EF4-FFF2-40B4-BE49-F238E27FC236}">
                    <a16:creationId xmlns:a16="http://schemas.microsoft.com/office/drawing/2014/main" id="{E9F3D495-03E6-8C5D-F198-D402EA11F611}"/>
                  </a:ext>
                </a:extLst>
              </p:cNvPr>
              <p:cNvSpPr txBox="1"/>
              <p:nvPr/>
            </p:nvSpPr>
            <p:spPr>
              <a:xfrm rot="16200000">
                <a:off x="2922183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HSJ633 4</a:t>
                </a:r>
              </a:p>
            </p:txBody>
          </p:sp>
        </p:grpSp>
      </p:grpSp>
      <p:grpSp>
        <p:nvGrpSpPr>
          <p:cNvPr id="28" name="Groupe 27">
            <a:extLst>
              <a:ext uri="{FF2B5EF4-FFF2-40B4-BE49-F238E27FC236}">
                <a16:creationId xmlns:a16="http://schemas.microsoft.com/office/drawing/2014/main" id="{F053EC35-7B2A-7CF0-904E-0846F31329F2}"/>
              </a:ext>
            </a:extLst>
          </p:cNvPr>
          <p:cNvGrpSpPr/>
          <p:nvPr/>
        </p:nvGrpSpPr>
        <p:grpSpPr>
          <a:xfrm>
            <a:off x="5912008" y="1089988"/>
            <a:ext cx="1641732" cy="947854"/>
            <a:chOff x="1104861" y="1005302"/>
            <a:chExt cx="1641732" cy="947854"/>
          </a:xfrm>
        </p:grpSpPr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3093385A-50BC-30F8-547D-DE940285E241}"/>
                </a:ext>
              </a:extLst>
            </p:cNvPr>
            <p:cNvSpPr txBox="1"/>
            <p:nvPr/>
          </p:nvSpPr>
          <p:spPr>
            <a:xfrm rot="16200000">
              <a:off x="1174593" y="1340729"/>
              <a:ext cx="9478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LPS 5</a:t>
              </a:r>
            </a:p>
          </p:txBody>
        </p:sp>
        <p:grpSp>
          <p:nvGrpSpPr>
            <p:cNvPr id="31" name="Groupe 30">
              <a:extLst>
                <a:ext uri="{FF2B5EF4-FFF2-40B4-BE49-F238E27FC236}">
                  <a16:creationId xmlns:a16="http://schemas.microsoft.com/office/drawing/2014/main" id="{0F9E5E1A-426A-874F-9665-F34C7EA8EF80}"/>
                </a:ext>
              </a:extLst>
            </p:cNvPr>
            <p:cNvGrpSpPr/>
            <p:nvPr/>
          </p:nvGrpSpPr>
          <p:grpSpPr>
            <a:xfrm>
              <a:off x="1104861" y="1005302"/>
              <a:ext cx="1641732" cy="947854"/>
              <a:chOff x="1104861" y="1005302"/>
              <a:chExt cx="1641732" cy="947854"/>
            </a:xfrm>
          </p:grpSpPr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CC51FDF5-4AE6-EFE0-26ED-FA40DC7C87B0}"/>
                  </a:ext>
                </a:extLst>
              </p:cNvPr>
              <p:cNvSpPr txBox="1"/>
              <p:nvPr/>
            </p:nvSpPr>
            <p:spPr>
              <a:xfrm rot="16200000">
                <a:off x="769434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SHAM 5 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319B6785-F411-29E3-A2B9-B467C066C595}"/>
                  </a:ext>
                </a:extLst>
              </p:cNvPr>
              <p:cNvSpPr txBox="1"/>
              <p:nvPr/>
            </p:nvSpPr>
            <p:spPr>
              <a:xfrm rot="16200000">
                <a:off x="966438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SHAM 6 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DC37ADB9-D369-878E-E46C-A37302283668}"/>
                  </a:ext>
                </a:extLst>
              </p:cNvPr>
              <p:cNvSpPr txBox="1"/>
              <p:nvPr/>
            </p:nvSpPr>
            <p:spPr>
              <a:xfrm rot="16200000">
                <a:off x="1387354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LPS 6</a:t>
                </a: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77FAC9D2-8CB8-657C-0D93-E9F306BBAC9F}"/>
                  </a:ext>
                </a:extLst>
              </p:cNvPr>
              <p:cNvSpPr txBox="1"/>
              <p:nvPr/>
            </p:nvSpPr>
            <p:spPr>
              <a:xfrm rot="16200000">
                <a:off x="1562057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633 5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1076C419-AA39-405F-10EE-5D12F2528F22}"/>
                  </a:ext>
                </a:extLst>
              </p:cNvPr>
              <p:cNvSpPr txBox="1"/>
              <p:nvPr/>
            </p:nvSpPr>
            <p:spPr>
              <a:xfrm rot="16200000">
                <a:off x="1747910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633 6 </a:t>
                </a:r>
              </a:p>
            </p:txBody>
          </p:sp>
          <p:sp>
            <p:nvSpPr>
              <p:cNvPr id="37" name="ZoneTexte 36">
                <a:extLst>
                  <a:ext uri="{FF2B5EF4-FFF2-40B4-BE49-F238E27FC236}">
                    <a16:creationId xmlns:a16="http://schemas.microsoft.com/office/drawing/2014/main" id="{B8CD16A7-F843-71F2-FADF-3F51763F8B13}"/>
                  </a:ext>
                </a:extLst>
              </p:cNvPr>
              <p:cNvSpPr txBox="1"/>
              <p:nvPr/>
            </p:nvSpPr>
            <p:spPr>
              <a:xfrm rot="16200000">
                <a:off x="1953241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LPS 7</a:t>
                </a:r>
              </a:p>
            </p:txBody>
          </p:sp>
          <p:sp>
            <p:nvSpPr>
              <p:cNvPr id="38" name="ZoneTexte 37">
                <a:extLst>
                  <a:ext uri="{FF2B5EF4-FFF2-40B4-BE49-F238E27FC236}">
                    <a16:creationId xmlns:a16="http://schemas.microsoft.com/office/drawing/2014/main" id="{6DC13E8D-4D01-BB4E-AD4E-CAF30A93DD17}"/>
                  </a:ext>
                </a:extLst>
              </p:cNvPr>
              <p:cNvSpPr txBox="1"/>
              <p:nvPr/>
            </p:nvSpPr>
            <p:spPr>
              <a:xfrm rot="16200000">
                <a:off x="2134167" y="1340729"/>
                <a:ext cx="9478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dirty="0"/>
                  <a:t>LPS 8</a:t>
                </a:r>
              </a:p>
            </p:txBody>
          </p:sp>
        </p:grpSp>
      </p:grpSp>
      <p:sp>
        <p:nvSpPr>
          <p:cNvPr id="42" name="ZoneTexte 41">
            <a:extLst>
              <a:ext uri="{FF2B5EF4-FFF2-40B4-BE49-F238E27FC236}">
                <a16:creationId xmlns:a16="http://schemas.microsoft.com/office/drawing/2014/main" id="{0681E2FA-584B-5154-B17D-46522FCA9C13}"/>
              </a:ext>
            </a:extLst>
          </p:cNvPr>
          <p:cNvSpPr txBox="1"/>
          <p:nvPr/>
        </p:nvSpPr>
        <p:spPr>
          <a:xfrm>
            <a:off x="54108" y="2340782"/>
            <a:ext cx="2406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pSTAT3 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090D1D31-E4E9-B502-BDA0-9FEEDC243CAE}"/>
              </a:ext>
            </a:extLst>
          </p:cNvPr>
          <p:cNvSpPr txBox="1"/>
          <p:nvPr/>
        </p:nvSpPr>
        <p:spPr>
          <a:xfrm>
            <a:off x="54108" y="3880439"/>
            <a:ext cx="2406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STAT3 </a:t>
            </a:r>
          </a:p>
        </p:txBody>
      </p:sp>
      <p:grpSp>
        <p:nvGrpSpPr>
          <p:cNvPr id="39" name="Groupe 38">
            <a:extLst>
              <a:ext uri="{FF2B5EF4-FFF2-40B4-BE49-F238E27FC236}">
                <a16:creationId xmlns:a16="http://schemas.microsoft.com/office/drawing/2014/main" id="{7B0D03D0-E615-0AF7-0FF4-A51BE4284324}"/>
              </a:ext>
            </a:extLst>
          </p:cNvPr>
          <p:cNvGrpSpPr/>
          <p:nvPr/>
        </p:nvGrpSpPr>
        <p:grpSpPr>
          <a:xfrm>
            <a:off x="1487835" y="1659100"/>
            <a:ext cx="787289" cy="1618848"/>
            <a:chOff x="1487835" y="1659100"/>
            <a:chExt cx="787289" cy="1618848"/>
          </a:xfrm>
        </p:grpSpPr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57793B72-244E-A982-5070-5372FD4511CF}"/>
                </a:ext>
              </a:extLst>
            </p:cNvPr>
            <p:cNvSpPr txBox="1"/>
            <p:nvPr/>
          </p:nvSpPr>
          <p:spPr>
            <a:xfrm>
              <a:off x="1546254" y="2470448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75</a:t>
              </a:r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A5AF0AA3-AED7-ECA3-F38B-F305DD152F5E}"/>
                </a:ext>
              </a:extLst>
            </p:cNvPr>
            <p:cNvSpPr txBox="1"/>
            <p:nvPr/>
          </p:nvSpPr>
          <p:spPr>
            <a:xfrm>
              <a:off x="1535103" y="274192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50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F9553C95-A968-430C-3A9B-4B61E889040F}"/>
                </a:ext>
              </a:extLst>
            </p:cNvPr>
            <p:cNvSpPr txBox="1"/>
            <p:nvPr/>
          </p:nvSpPr>
          <p:spPr>
            <a:xfrm>
              <a:off x="1546254" y="3000949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37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58164E2C-5200-66BE-D4EF-C5D6E4C8D8F8}"/>
                </a:ext>
              </a:extLst>
            </p:cNvPr>
            <p:cNvSpPr txBox="1"/>
            <p:nvPr/>
          </p:nvSpPr>
          <p:spPr>
            <a:xfrm>
              <a:off x="1487835" y="2147805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50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2A5FBD14-403D-1179-0221-AE7093F8AC00}"/>
                </a:ext>
              </a:extLst>
            </p:cNvPr>
            <p:cNvSpPr txBox="1"/>
            <p:nvPr/>
          </p:nvSpPr>
          <p:spPr>
            <a:xfrm>
              <a:off x="1487835" y="2298471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00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3CBE9B2C-66F4-AB7B-F5FB-845C5660B5DA}"/>
                </a:ext>
              </a:extLst>
            </p:cNvPr>
            <p:cNvSpPr txBox="1"/>
            <p:nvPr/>
          </p:nvSpPr>
          <p:spPr>
            <a:xfrm>
              <a:off x="1503915" y="200093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250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206C04F8-DA1A-3D36-6BE6-79A7125D7AFA}"/>
                </a:ext>
              </a:extLst>
            </p:cNvPr>
            <p:cNvSpPr txBox="1"/>
            <p:nvPr/>
          </p:nvSpPr>
          <p:spPr>
            <a:xfrm>
              <a:off x="1487835" y="1659100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err="1"/>
                <a:t>kDa</a:t>
              </a:r>
              <a:endParaRPr lang="en-CA" sz="1200" dirty="0"/>
            </a:p>
          </p:txBody>
        </p:sp>
      </p:grpSp>
      <p:grpSp>
        <p:nvGrpSpPr>
          <p:cNvPr id="40" name="Groupe 39">
            <a:extLst>
              <a:ext uri="{FF2B5EF4-FFF2-40B4-BE49-F238E27FC236}">
                <a16:creationId xmlns:a16="http://schemas.microsoft.com/office/drawing/2014/main" id="{740194F3-BFFE-0AFC-3EB0-4A9191D7F36A}"/>
              </a:ext>
            </a:extLst>
          </p:cNvPr>
          <p:cNvGrpSpPr/>
          <p:nvPr/>
        </p:nvGrpSpPr>
        <p:grpSpPr>
          <a:xfrm>
            <a:off x="1429416" y="3429000"/>
            <a:ext cx="787289" cy="1618848"/>
            <a:chOff x="1487835" y="1659100"/>
            <a:chExt cx="787289" cy="1618848"/>
          </a:xfrm>
        </p:grpSpPr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34D3E61C-DAB2-CCD6-75B8-369642B414EE}"/>
                </a:ext>
              </a:extLst>
            </p:cNvPr>
            <p:cNvSpPr txBox="1"/>
            <p:nvPr/>
          </p:nvSpPr>
          <p:spPr>
            <a:xfrm>
              <a:off x="1546254" y="2470448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75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3CD1444E-D8B1-CD5E-40B3-74932F7B7BD1}"/>
                </a:ext>
              </a:extLst>
            </p:cNvPr>
            <p:cNvSpPr txBox="1"/>
            <p:nvPr/>
          </p:nvSpPr>
          <p:spPr>
            <a:xfrm>
              <a:off x="1535103" y="274192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50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C260B9B8-1154-A1FC-7226-8DC2F30D80C4}"/>
                </a:ext>
              </a:extLst>
            </p:cNvPr>
            <p:cNvSpPr txBox="1"/>
            <p:nvPr/>
          </p:nvSpPr>
          <p:spPr>
            <a:xfrm>
              <a:off x="1546254" y="3000949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37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BB5F61FB-5E92-EB67-0348-470CC1C86771}"/>
                </a:ext>
              </a:extLst>
            </p:cNvPr>
            <p:cNvSpPr txBox="1"/>
            <p:nvPr/>
          </p:nvSpPr>
          <p:spPr>
            <a:xfrm>
              <a:off x="1487835" y="2147805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50</a:t>
              </a:r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B4E33A09-9A71-0F7F-49FD-CF1A3E653D13}"/>
                </a:ext>
              </a:extLst>
            </p:cNvPr>
            <p:cNvSpPr txBox="1"/>
            <p:nvPr/>
          </p:nvSpPr>
          <p:spPr>
            <a:xfrm>
              <a:off x="1487835" y="2298471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00</a:t>
              </a: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CB9F7E39-C7E1-777E-82A8-0171AD574D4B}"/>
                </a:ext>
              </a:extLst>
            </p:cNvPr>
            <p:cNvSpPr txBox="1"/>
            <p:nvPr/>
          </p:nvSpPr>
          <p:spPr>
            <a:xfrm>
              <a:off x="1503915" y="200093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250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2B0A426A-42E4-AC32-0986-476A2621BF11}"/>
                </a:ext>
              </a:extLst>
            </p:cNvPr>
            <p:cNvSpPr txBox="1"/>
            <p:nvPr/>
          </p:nvSpPr>
          <p:spPr>
            <a:xfrm>
              <a:off x="1487835" y="1659100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err="1"/>
                <a:t>kDa</a:t>
              </a:r>
              <a:endParaRPr lang="en-CA" sz="1200" dirty="0"/>
            </a:p>
          </p:txBody>
        </p:sp>
      </p:grpSp>
      <p:grpSp>
        <p:nvGrpSpPr>
          <p:cNvPr id="50" name="Groupe 49">
            <a:extLst>
              <a:ext uri="{FF2B5EF4-FFF2-40B4-BE49-F238E27FC236}">
                <a16:creationId xmlns:a16="http://schemas.microsoft.com/office/drawing/2014/main" id="{46BC0026-8CCB-FBFC-791E-822DB0306EAD}"/>
              </a:ext>
            </a:extLst>
          </p:cNvPr>
          <p:cNvGrpSpPr/>
          <p:nvPr/>
        </p:nvGrpSpPr>
        <p:grpSpPr>
          <a:xfrm>
            <a:off x="5390204" y="1659100"/>
            <a:ext cx="787289" cy="1359821"/>
            <a:chOff x="1487835" y="1659100"/>
            <a:chExt cx="787289" cy="1359821"/>
          </a:xfrm>
        </p:grpSpPr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A7A29B6E-4FE6-0DF9-C4F6-BF09C24B95C8}"/>
                </a:ext>
              </a:extLst>
            </p:cNvPr>
            <p:cNvSpPr txBox="1"/>
            <p:nvPr/>
          </p:nvSpPr>
          <p:spPr>
            <a:xfrm>
              <a:off x="1546254" y="2470448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75</a:t>
              </a:r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CD975E5A-169B-55F1-2643-B58079C5D74A}"/>
                </a:ext>
              </a:extLst>
            </p:cNvPr>
            <p:cNvSpPr txBox="1"/>
            <p:nvPr/>
          </p:nvSpPr>
          <p:spPr>
            <a:xfrm>
              <a:off x="1535103" y="274192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50</a:t>
              </a:r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7A0145E9-62F4-F1A1-0855-9742A106026D}"/>
                </a:ext>
              </a:extLst>
            </p:cNvPr>
            <p:cNvSpPr txBox="1"/>
            <p:nvPr/>
          </p:nvSpPr>
          <p:spPr>
            <a:xfrm>
              <a:off x="1487835" y="2147805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50</a:t>
              </a:r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49D700FE-9BCE-9B46-4663-E5B43DDBA0AE}"/>
                </a:ext>
              </a:extLst>
            </p:cNvPr>
            <p:cNvSpPr txBox="1"/>
            <p:nvPr/>
          </p:nvSpPr>
          <p:spPr>
            <a:xfrm>
              <a:off x="1487835" y="2298471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00</a:t>
              </a:r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7EFB7C1B-0B7E-B412-93A0-A7AF2CA72B9E}"/>
                </a:ext>
              </a:extLst>
            </p:cNvPr>
            <p:cNvSpPr txBox="1"/>
            <p:nvPr/>
          </p:nvSpPr>
          <p:spPr>
            <a:xfrm>
              <a:off x="1503915" y="200093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250</a:t>
              </a:r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CC94302E-5B74-5E3E-C300-47C31EF0AA66}"/>
                </a:ext>
              </a:extLst>
            </p:cNvPr>
            <p:cNvSpPr txBox="1"/>
            <p:nvPr/>
          </p:nvSpPr>
          <p:spPr>
            <a:xfrm>
              <a:off x="1487835" y="1659100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err="1"/>
                <a:t>kDa</a:t>
              </a:r>
              <a:endParaRPr lang="en-CA" sz="1200" dirty="0"/>
            </a:p>
          </p:txBody>
        </p:sp>
      </p:grpSp>
      <p:grpSp>
        <p:nvGrpSpPr>
          <p:cNvPr id="58" name="Groupe 57">
            <a:extLst>
              <a:ext uri="{FF2B5EF4-FFF2-40B4-BE49-F238E27FC236}">
                <a16:creationId xmlns:a16="http://schemas.microsoft.com/office/drawing/2014/main" id="{600F2900-B078-6655-6686-38520A8FBE13}"/>
              </a:ext>
            </a:extLst>
          </p:cNvPr>
          <p:cNvGrpSpPr/>
          <p:nvPr/>
        </p:nvGrpSpPr>
        <p:grpSpPr>
          <a:xfrm>
            <a:off x="5449570" y="3481913"/>
            <a:ext cx="787289" cy="1359821"/>
            <a:chOff x="1487835" y="1659100"/>
            <a:chExt cx="787289" cy="1359821"/>
          </a:xfrm>
        </p:grpSpPr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3A88D647-A9C4-1799-126A-59A085FCF28F}"/>
                </a:ext>
              </a:extLst>
            </p:cNvPr>
            <p:cNvSpPr txBox="1"/>
            <p:nvPr/>
          </p:nvSpPr>
          <p:spPr>
            <a:xfrm>
              <a:off x="1546254" y="2470448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75</a:t>
              </a:r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2DD814FF-9CFB-A571-1903-4F0C528D7A1C}"/>
                </a:ext>
              </a:extLst>
            </p:cNvPr>
            <p:cNvSpPr txBox="1"/>
            <p:nvPr/>
          </p:nvSpPr>
          <p:spPr>
            <a:xfrm>
              <a:off x="1535103" y="274192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50</a:t>
              </a:r>
            </a:p>
          </p:txBody>
        </p:sp>
        <p:sp>
          <p:nvSpPr>
            <p:cNvPr id="61" name="ZoneTexte 60">
              <a:extLst>
                <a:ext uri="{FF2B5EF4-FFF2-40B4-BE49-F238E27FC236}">
                  <a16:creationId xmlns:a16="http://schemas.microsoft.com/office/drawing/2014/main" id="{811AA13E-515E-3E70-A7E5-92CC847D9642}"/>
                </a:ext>
              </a:extLst>
            </p:cNvPr>
            <p:cNvSpPr txBox="1"/>
            <p:nvPr/>
          </p:nvSpPr>
          <p:spPr>
            <a:xfrm>
              <a:off x="1487835" y="2147805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50</a:t>
              </a:r>
            </a:p>
          </p:txBody>
        </p:sp>
        <p:sp>
          <p:nvSpPr>
            <p:cNvPr id="62" name="ZoneTexte 61">
              <a:extLst>
                <a:ext uri="{FF2B5EF4-FFF2-40B4-BE49-F238E27FC236}">
                  <a16:creationId xmlns:a16="http://schemas.microsoft.com/office/drawing/2014/main" id="{77BB6A04-2771-B491-2351-03AC1B2D39AC}"/>
                </a:ext>
              </a:extLst>
            </p:cNvPr>
            <p:cNvSpPr txBox="1"/>
            <p:nvPr/>
          </p:nvSpPr>
          <p:spPr>
            <a:xfrm>
              <a:off x="1487835" y="2298471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100</a:t>
              </a:r>
            </a:p>
          </p:txBody>
        </p:sp>
        <p:sp>
          <p:nvSpPr>
            <p:cNvPr id="63" name="ZoneTexte 62">
              <a:extLst>
                <a:ext uri="{FF2B5EF4-FFF2-40B4-BE49-F238E27FC236}">
                  <a16:creationId xmlns:a16="http://schemas.microsoft.com/office/drawing/2014/main" id="{39AD6D3C-776E-7C28-7BD5-B6AF8093739B}"/>
                </a:ext>
              </a:extLst>
            </p:cNvPr>
            <p:cNvSpPr txBox="1"/>
            <p:nvPr/>
          </p:nvSpPr>
          <p:spPr>
            <a:xfrm>
              <a:off x="1503915" y="2000932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/>
                <a:t>250</a:t>
              </a:r>
            </a:p>
          </p:txBody>
        </p:sp>
        <p:sp>
          <p:nvSpPr>
            <p:cNvPr id="64" name="ZoneTexte 63">
              <a:extLst>
                <a:ext uri="{FF2B5EF4-FFF2-40B4-BE49-F238E27FC236}">
                  <a16:creationId xmlns:a16="http://schemas.microsoft.com/office/drawing/2014/main" id="{2EDEA603-471B-0CC1-8375-AA23CBCB1056}"/>
                </a:ext>
              </a:extLst>
            </p:cNvPr>
            <p:cNvSpPr txBox="1"/>
            <p:nvPr/>
          </p:nvSpPr>
          <p:spPr>
            <a:xfrm>
              <a:off x="1487835" y="1659100"/>
              <a:ext cx="728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 err="1"/>
                <a:t>kDa</a:t>
              </a:r>
              <a:endParaRPr lang="en-CA" sz="1200" dirty="0"/>
            </a:p>
          </p:txBody>
        </p:sp>
      </p:grpSp>
      <p:sp>
        <p:nvSpPr>
          <p:cNvPr id="65" name="ZoneTexte 64">
            <a:extLst>
              <a:ext uri="{FF2B5EF4-FFF2-40B4-BE49-F238E27FC236}">
                <a16:creationId xmlns:a16="http://schemas.microsoft.com/office/drawing/2014/main" id="{F0CAC492-A9FC-A6FF-FD97-4C37719C9894}"/>
              </a:ext>
            </a:extLst>
          </p:cNvPr>
          <p:cNvSpPr txBox="1"/>
          <p:nvPr/>
        </p:nvSpPr>
        <p:spPr>
          <a:xfrm>
            <a:off x="5492163" y="4874207"/>
            <a:ext cx="728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37</a:t>
            </a:r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id="{81D75595-0BD6-C082-8F35-C90D5B984766}"/>
              </a:ext>
            </a:extLst>
          </p:cNvPr>
          <p:cNvSpPr txBox="1"/>
          <p:nvPr/>
        </p:nvSpPr>
        <p:spPr>
          <a:xfrm>
            <a:off x="5439974" y="3011160"/>
            <a:ext cx="728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37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C7CCFB02-83C0-4762-10D1-0CAA9AE2C7E1}"/>
              </a:ext>
            </a:extLst>
          </p:cNvPr>
          <p:cNvSpPr/>
          <p:nvPr/>
        </p:nvSpPr>
        <p:spPr>
          <a:xfrm>
            <a:off x="5994563" y="2396112"/>
            <a:ext cx="1205327" cy="27412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02CD3052-B3B8-7AD6-2845-B77DF57C8485}"/>
              </a:ext>
            </a:extLst>
          </p:cNvPr>
          <p:cNvSpPr/>
          <p:nvPr/>
        </p:nvSpPr>
        <p:spPr>
          <a:xfrm>
            <a:off x="5994563" y="4213714"/>
            <a:ext cx="1205327" cy="27412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E420821A-49FE-CA24-A22D-587CAF7AC522}"/>
              </a:ext>
            </a:extLst>
          </p:cNvPr>
          <p:cNvSpPr txBox="1"/>
          <p:nvPr/>
        </p:nvSpPr>
        <p:spPr>
          <a:xfrm rot="16200000">
            <a:off x="1703891" y="558147"/>
            <a:ext cx="2400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TEST  – Not included 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492D3260-293B-EFA1-9996-3B54389C504A}"/>
              </a:ext>
            </a:extLst>
          </p:cNvPr>
          <p:cNvSpPr txBox="1"/>
          <p:nvPr/>
        </p:nvSpPr>
        <p:spPr>
          <a:xfrm rot="16200000">
            <a:off x="2271690" y="957085"/>
            <a:ext cx="1602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TEST  – Not included </a:t>
            </a:r>
          </a:p>
        </p:txBody>
      </p:sp>
      <p:grpSp>
        <p:nvGrpSpPr>
          <p:cNvPr id="20" name="Groupe 19">
            <a:extLst>
              <a:ext uri="{FF2B5EF4-FFF2-40B4-BE49-F238E27FC236}">
                <a16:creationId xmlns:a16="http://schemas.microsoft.com/office/drawing/2014/main" id="{85703773-D8FD-1D6E-BF92-9736952178F3}"/>
              </a:ext>
            </a:extLst>
          </p:cNvPr>
          <p:cNvGrpSpPr/>
          <p:nvPr/>
        </p:nvGrpSpPr>
        <p:grpSpPr>
          <a:xfrm>
            <a:off x="8130312" y="1840599"/>
            <a:ext cx="2435266" cy="1107757"/>
            <a:chOff x="6091699" y="1909685"/>
            <a:chExt cx="2435266" cy="1107526"/>
          </a:xfrm>
        </p:grpSpPr>
        <p:grpSp>
          <p:nvGrpSpPr>
            <p:cNvPr id="53" name="Groupe 52">
              <a:extLst>
                <a:ext uri="{FF2B5EF4-FFF2-40B4-BE49-F238E27FC236}">
                  <a16:creationId xmlns:a16="http://schemas.microsoft.com/office/drawing/2014/main" id="{9E0BD384-3351-7217-28DA-3E55F5B58304}"/>
                </a:ext>
              </a:extLst>
            </p:cNvPr>
            <p:cNvGrpSpPr/>
            <p:nvPr/>
          </p:nvGrpSpPr>
          <p:grpSpPr>
            <a:xfrm>
              <a:off x="6091699" y="2116023"/>
              <a:ext cx="2435266" cy="901188"/>
              <a:chOff x="5426491" y="2116023"/>
              <a:chExt cx="2435266" cy="901188"/>
            </a:xfrm>
          </p:grpSpPr>
          <p:pic>
            <p:nvPicPr>
              <p:cNvPr id="71" name="Image 70">
                <a:extLst>
                  <a:ext uri="{FF2B5EF4-FFF2-40B4-BE49-F238E27FC236}">
                    <a16:creationId xmlns:a16="http://schemas.microsoft.com/office/drawing/2014/main" id="{0CAC32F0-11A7-B185-30EA-D7304E1F70C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9764" t="18342" r="24372" b="76557"/>
              <a:stretch/>
            </p:blipFill>
            <p:spPr>
              <a:xfrm>
                <a:off x="5986800" y="2367864"/>
                <a:ext cx="1233671" cy="277142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grpSp>
            <p:nvGrpSpPr>
              <p:cNvPr id="72" name="Groupe 71">
                <a:extLst>
                  <a:ext uri="{FF2B5EF4-FFF2-40B4-BE49-F238E27FC236}">
                    <a16:creationId xmlns:a16="http://schemas.microsoft.com/office/drawing/2014/main" id="{6EE0C509-386E-2A43-9FE2-596BAA7EC7E7}"/>
                  </a:ext>
                </a:extLst>
              </p:cNvPr>
              <p:cNvGrpSpPr/>
              <p:nvPr/>
            </p:nvGrpSpPr>
            <p:grpSpPr>
              <a:xfrm>
                <a:off x="5426491" y="2116023"/>
                <a:ext cx="2435266" cy="901188"/>
                <a:chOff x="5426491" y="2116023"/>
                <a:chExt cx="2435266" cy="901188"/>
              </a:xfrm>
            </p:grpSpPr>
            <p:pic>
              <p:nvPicPr>
                <p:cNvPr id="73" name="Image 72">
                  <a:extLst>
                    <a:ext uri="{FF2B5EF4-FFF2-40B4-BE49-F238E27FC236}">
                      <a16:creationId xmlns:a16="http://schemas.microsoft.com/office/drawing/2014/main" id="{A19391BD-9A49-4FB9-D2E9-020CFC66049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45361" t="54077" r="38775" b="41287"/>
                <a:stretch/>
              </p:blipFill>
              <p:spPr>
                <a:xfrm>
                  <a:off x="5986800" y="2759276"/>
                  <a:ext cx="1233035" cy="251793"/>
                </a:xfrm>
                <a:prstGeom prst="rect">
                  <a:avLst/>
                </a:prstGeom>
                <a:ln w="19050">
                  <a:solidFill>
                    <a:schemeClr val="tx1"/>
                  </a:solidFill>
                </a:ln>
              </p:spPr>
            </p:pic>
            <p:grpSp>
              <p:nvGrpSpPr>
                <p:cNvPr id="74" name="Groupe 73">
                  <a:extLst>
                    <a:ext uri="{FF2B5EF4-FFF2-40B4-BE49-F238E27FC236}">
                      <a16:creationId xmlns:a16="http://schemas.microsoft.com/office/drawing/2014/main" id="{4A1073A5-9145-172A-D524-DE635112C5ED}"/>
                    </a:ext>
                  </a:extLst>
                </p:cNvPr>
                <p:cNvGrpSpPr/>
                <p:nvPr/>
              </p:nvGrpSpPr>
              <p:grpSpPr>
                <a:xfrm>
                  <a:off x="5426491" y="2116023"/>
                  <a:ext cx="2435266" cy="901188"/>
                  <a:chOff x="5426491" y="2116023"/>
                  <a:chExt cx="2435266" cy="901188"/>
                </a:xfrm>
              </p:grpSpPr>
              <p:grpSp>
                <p:nvGrpSpPr>
                  <p:cNvPr id="75" name="Groupe 74">
                    <a:extLst>
                      <a:ext uri="{FF2B5EF4-FFF2-40B4-BE49-F238E27FC236}">
                        <a16:creationId xmlns:a16="http://schemas.microsoft.com/office/drawing/2014/main" id="{C3FD7ADE-1E01-8C6B-32B1-93E1E0D9279C}"/>
                      </a:ext>
                    </a:extLst>
                  </p:cNvPr>
                  <p:cNvGrpSpPr/>
                  <p:nvPr/>
                </p:nvGrpSpPr>
                <p:grpSpPr>
                  <a:xfrm>
                    <a:off x="5926842" y="2116023"/>
                    <a:ext cx="1709550" cy="276999"/>
                    <a:chOff x="1099817" y="1610900"/>
                    <a:chExt cx="1709550" cy="276999"/>
                  </a:xfrm>
                </p:grpSpPr>
                <p:sp>
                  <p:nvSpPr>
                    <p:cNvPr id="80" name="ZoneTexte 79">
                      <a:extLst>
                        <a:ext uri="{FF2B5EF4-FFF2-40B4-BE49-F238E27FC236}">
                          <a16:creationId xmlns:a16="http://schemas.microsoft.com/office/drawing/2014/main" id="{C28F7B6B-0C99-7EC9-20F9-FAD03B293D4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26569" y="1610900"/>
                      <a:ext cx="48192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CA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h</a:t>
                      </a:r>
                      <a:endParaRPr lang="en-CA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81" name="Groupe 80">
                      <a:extLst>
                        <a:ext uri="{FF2B5EF4-FFF2-40B4-BE49-F238E27FC236}">
                          <a16:creationId xmlns:a16="http://schemas.microsoft.com/office/drawing/2014/main" id="{91A1B5C5-EF59-EC4E-8732-9BFF082555C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99817" y="1610900"/>
                      <a:ext cx="1709550" cy="276999"/>
                      <a:chOff x="1099817" y="1610900"/>
                      <a:chExt cx="1709550" cy="276999"/>
                    </a:xfrm>
                  </p:grpSpPr>
                  <p:sp>
                    <p:nvSpPr>
                      <p:cNvPr id="82" name="ZoneTexte 81">
                        <a:extLst>
                          <a:ext uri="{FF2B5EF4-FFF2-40B4-BE49-F238E27FC236}">
                            <a16:creationId xmlns:a16="http://schemas.microsoft.com/office/drawing/2014/main" id="{4E819CA9-C92B-EC44-24F6-CBDF34BF3A1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99817" y="1610900"/>
                        <a:ext cx="58699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CA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ham </a:t>
                        </a:r>
                      </a:p>
                    </p:txBody>
                  </p:sp>
                  <p:sp>
                    <p:nvSpPr>
                      <p:cNvPr id="83" name="ZoneTexte 82">
                        <a:extLst>
                          <a:ext uri="{FF2B5EF4-FFF2-40B4-BE49-F238E27FC236}">
                            <a16:creationId xmlns:a16="http://schemas.microsoft.com/office/drawing/2014/main" id="{23CA76EF-DA4A-9A2D-CC65-BF3AF923F3E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61513" y="1610900"/>
                        <a:ext cx="94785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CA" sz="12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SJ633 </a:t>
                        </a:r>
                      </a:p>
                    </p:txBody>
                  </p:sp>
                </p:grpSp>
              </p:grpSp>
              <p:sp>
                <p:nvSpPr>
                  <p:cNvPr id="76" name="ZoneTexte 75">
                    <a:extLst>
                      <a:ext uri="{FF2B5EF4-FFF2-40B4-BE49-F238E27FC236}">
                        <a16:creationId xmlns:a16="http://schemas.microsoft.com/office/drawing/2014/main" id="{FAC5DF01-AFB0-F9C0-3122-E196C6700BC6}"/>
                      </a:ext>
                    </a:extLst>
                  </p:cNvPr>
                  <p:cNvSpPr txBox="1"/>
                  <p:nvPr/>
                </p:nvSpPr>
                <p:spPr>
                  <a:xfrm>
                    <a:off x="5426491" y="2404214"/>
                    <a:ext cx="73730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CA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STAT3</a:t>
                    </a:r>
                    <a:r>
                      <a:rPr lang="en-CA" sz="1000" dirty="0"/>
                      <a:t> </a:t>
                    </a:r>
                  </a:p>
                </p:txBody>
              </p:sp>
              <p:sp>
                <p:nvSpPr>
                  <p:cNvPr id="77" name="ZoneTexte 76">
                    <a:extLst>
                      <a:ext uri="{FF2B5EF4-FFF2-40B4-BE49-F238E27FC236}">
                        <a16:creationId xmlns:a16="http://schemas.microsoft.com/office/drawing/2014/main" id="{0F2A1285-C6F4-8D1B-4E3D-A0B10E97E397}"/>
                      </a:ext>
                    </a:extLst>
                  </p:cNvPr>
                  <p:cNvSpPr txBox="1"/>
                  <p:nvPr/>
                </p:nvSpPr>
                <p:spPr>
                  <a:xfrm>
                    <a:off x="5426491" y="2771041"/>
                    <a:ext cx="880924" cy="2461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CA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tSTAT3 </a:t>
                    </a:r>
                  </a:p>
                </p:txBody>
              </p:sp>
              <p:sp>
                <p:nvSpPr>
                  <p:cNvPr id="78" name="ZoneTexte 77">
                    <a:extLst>
                      <a:ext uri="{FF2B5EF4-FFF2-40B4-BE49-F238E27FC236}">
                        <a16:creationId xmlns:a16="http://schemas.microsoft.com/office/drawing/2014/main" id="{A2F44EF2-7349-58AC-2DF7-8D6D79C1D3EF}"/>
                      </a:ext>
                    </a:extLst>
                  </p:cNvPr>
                  <p:cNvSpPr txBox="1"/>
                  <p:nvPr/>
                </p:nvSpPr>
                <p:spPr>
                  <a:xfrm>
                    <a:off x="7179272" y="2361161"/>
                    <a:ext cx="682485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CA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9 </a:t>
                    </a:r>
                    <a:r>
                      <a:rPr lang="en-CA" sz="10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en-CA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9" name="ZoneTexte 78">
                    <a:extLst>
                      <a:ext uri="{FF2B5EF4-FFF2-40B4-BE49-F238E27FC236}">
                        <a16:creationId xmlns:a16="http://schemas.microsoft.com/office/drawing/2014/main" id="{90A147F9-CE8F-7ABC-38B0-5A5661CAD88C}"/>
                      </a:ext>
                    </a:extLst>
                  </p:cNvPr>
                  <p:cNvSpPr txBox="1"/>
                  <p:nvPr/>
                </p:nvSpPr>
                <p:spPr>
                  <a:xfrm>
                    <a:off x="7179272" y="2700148"/>
                    <a:ext cx="682485" cy="2517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CA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9 </a:t>
                    </a:r>
                    <a:r>
                      <a:rPr lang="en-CA" sz="10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en-CA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</p:grpSp>
        <p:cxnSp>
          <p:nvCxnSpPr>
            <p:cNvPr id="68" name="Connecteur droit 67">
              <a:extLst>
                <a:ext uri="{FF2B5EF4-FFF2-40B4-BE49-F238E27FC236}">
                  <a16:creationId xmlns:a16="http://schemas.microsoft.com/office/drawing/2014/main" id="{50B1FDA4-9FDA-EF47-4D91-413A895AC305}"/>
                </a:ext>
              </a:extLst>
            </p:cNvPr>
            <p:cNvCxnSpPr>
              <a:cxnSpLocks/>
            </p:cNvCxnSpPr>
            <p:nvPr/>
          </p:nvCxnSpPr>
          <p:spPr>
            <a:xfrm>
              <a:off x="7101371" y="2118742"/>
              <a:ext cx="72630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70" name="ZoneTexte 69">
              <a:extLst>
                <a:ext uri="{FF2B5EF4-FFF2-40B4-BE49-F238E27FC236}">
                  <a16:creationId xmlns:a16="http://schemas.microsoft.com/office/drawing/2014/main" id="{6E30674E-AFB8-C0D9-BACA-01D185BF69B3}"/>
                </a:ext>
              </a:extLst>
            </p:cNvPr>
            <p:cNvSpPr txBox="1"/>
            <p:nvPr/>
          </p:nvSpPr>
          <p:spPr>
            <a:xfrm>
              <a:off x="7235711" y="1909685"/>
              <a:ext cx="5741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LP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234433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87</Words>
  <Application>Microsoft Macintosh PowerPoint</Application>
  <PresentationFormat>Grand écran</PresentationFormat>
  <Paragraphs>5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ce Côté</dc:creator>
  <cp:lastModifiedBy>France Côté</cp:lastModifiedBy>
  <cp:revision>4</cp:revision>
  <dcterms:created xsi:type="dcterms:W3CDTF">2023-08-15T14:27:21Z</dcterms:created>
  <dcterms:modified xsi:type="dcterms:W3CDTF">2024-11-08T16:38:27Z</dcterms:modified>
</cp:coreProperties>
</file>